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8999538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09"/>
    <p:restoredTop sz="96327"/>
  </p:normalViewPr>
  <p:slideViewPr>
    <p:cSldViewPr snapToGrid="0" snapToObjects="1">
      <p:cViewPr>
        <p:scale>
          <a:sx n="189" d="100"/>
          <a:sy n="189" d="100"/>
        </p:scale>
        <p:origin x="216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22363"/>
            <a:ext cx="7649607" cy="2387600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602038"/>
            <a:ext cx="6749654" cy="165576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775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592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65125"/>
            <a:ext cx="194052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65125"/>
            <a:ext cx="5709082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367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100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09740"/>
            <a:ext cx="7762102" cy="2852737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589465"/>
            <a:ext cx="7762102" cy="150018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482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825625"/>
            <a:ext cx="3824804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825625"/>
            <a:ext cx="3824804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300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65127"/>
            <a:ext cx="7762102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681163"/>
            <a:ext cx="3807226" cy="82391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505075"/>
            <a:ext cx="3807226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681163"/>
            <a:ext cx="3825976" cy="82391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505075"/>
            <a:ext cx="3825976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876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22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315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57200"/>
            <a:ext cx="2902585" cy="16002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987427"/>
            <a:ext cx="4556016" cy="487362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057400"/>
            <a:ext cx="2902585" cy="3811588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808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57200"/>
            <a:ext cx="2902585" cy="16002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987427"/>
            <a:ext cx="4556016" cy="487362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057400"/>
            <a:ext cx="2902585" cy="3811588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602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65127"/>
            <a:ext cx="776210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825625"/>
            <a:ext cx="776210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356352"/>
            <a:ext cx="202489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2B309-9837-7843-8E20-6BF87E98F064}" type="datetimeFigureOut">
              <a:rPr kumimoji="1" lang="ja-JP" altLang="en-US" smtClean="0"/>
              <a:t>2019/3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356352"/>
            <a:ext cx="303734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356352"/>
            <a:ext cx="202489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EBB9F-F420-FB42-92EA-79D81FC3E7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513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kumimoji="1"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図 106">
            <a:extLst>
              <a:ext uri="{FF2B5EF4-FFF2-40B4-BE49-F238E27FC236}">
                <a16:creationId xmlns:a16="http://schemas.microsoft.com/office/drawing/2014/main" id="{87F0B517-329A-344A-9DBF-AC0A69A0CE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94" r="16691" b="2971"/>
          <a:stretch/>
        </p:blipFill>
        <p:spPr>
          <a:xfrm>
            <a:off x="171882" y="1531828"/>
            <a:ext cx="3658753" cy="4470211"/>
          </a:xfrm>
          <a:prstGeom prst="rect">
            <a:avLst/>
          </a:prstGeom>
        </p:spPr>
      </p:pic>
      <p:pic>
        <p:nvPicPr>
          <p:cNvPr id="109" name="図 108">
            <a:extLst>
              <a:ext uri="{FF2B5EF4-FFF2-40B4-BE49-F238E27FC236}">
                <a16:creationId xmlns:a16="http://schemas.microsoft.com/office/drawing/2014/main" id="{87DB5ACA-C0DC-B740-9C62-5D1224E651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93" r="16612" b="2990"/>
          <a:stretch/>
        </p:blipFill>
        <p:spPr>
          <a:xfrm>
            <a:off x="4578323" y="1492114"/>
            <a:ext cx="3663142" cy="4470210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0CD87FE-1C4C-4D43-B553-BB190DA0A4E1}"/>
              </a:ext>
            </a:extLst>
          </p:cNvPr>
          <p:cNvSpPr txBox="1"/>
          <p:nvPr/>
        </p:nvSpPr>
        <p:spPr>
          <a:xfrm>
            <a:off x="-7486" y="0"/>
            <a:ext cx="1956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dditional Figure 4</a:t>
            </a:r>
            <a:endParaRPr lang="ja-JP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B3638F9-0EE7-E740-8C8B-3E23AA9F0BEF}"/>
              </a:ext>
            </a:extLst>
          </p:cNvPr>
          <p:cNvSpPr txBox="1"/>
          <p:nvPr/>
        </p:nvSpPr>
        <p:spPr>
          <a:xfrm>
            <a:off x="3583533" y="1372040"/>
            <a:ext cx="72648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Cell type</a:t>
            </a:r>
            <a:endParaRPr kumimoji="1" lang="ja-JP" altLang="en-US" sz="12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E88AA95-F054-764D-AA19-EE8C13B5B13E}"/>
              </a:ext>
            </a:extLst>
          </p:cNvPr>
          <p:cNvSpPr txBox="1"/>
          <p:nvPr/>
        </p:nvSpPr>
        <p:spPr>
          <a:xfrm>
            <a:off x="1718753" y="5963624"/>
            <a:ext cx="72648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Cell type</a:t>
            </a:r>
            <a:endParaRPr kumimoji="1" lang="ja-JP" altLang="en-US" sz="120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7BF0EB6-0501-0140-845A-230C40AE6624}"/>
              </a:ext>
            </a:extLst>
          </p:cNvPr>
          <p:cNvSpPr txBox="1"/>
          <p:nvPr/>
        </p:nvSpPr>
        <p:spPr>
          <a:xfrm>
            <a:off x="6133721" y="5963624"/>
            <a:ext cx="72648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Cell type</a:t>
            </a:r>
            <a:endParaRPr kumimoji="1" lang="ja-JP" altLang="en-US" sz="1200"/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6878183E-7F19-EF45-8307-F3E394E9EA79}"/>
              </a:ext>
            </a:extLst>
          </p:cNvPr>
          <p:cNvGrpSpPr/>
          <p:nvPr/>
        </p:nvGrpSpPr>
        <p:grpSpPr>
          <a:xfrm>
            <a:off x="776274" y="1602556"/>
            <a:ext cx="450851" cy="86200"/>
            <a:chOff x="894948" y="628023"/>
            <a:chExt cx="556890" cy="121752"/>
          </a:xfrm>
        </p:grpSpPr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909800D-E2C2-FD40-9E47-720C16CA0ABA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454A09D8-F498-8C48-A3C2-86B115ABBDAF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D8A59B3F-A910-754C-B715-E6D253708E26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79047730-4191-4140-9C34-950D19DD819E}"/>
              </a:ext>
            </a:extLst>
          </p:cNvPr>
          <p:cNvGrpSpPr/>
          <p:nvPr/>
        </p:nvGrpSpPr>
        <p:grpSpPr>
          <a:xfrm>
            <a:off x="1227125" y="1488037"/>
            <a:ext cx="450851" cy="86200"/>
            <a:chOff x="894948" y="628023"/>
            <a:chExt cx="556890" cy="121752"/>
          </a:xfrm>
        </p:grpSpPr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7E40236D-DE6E-DA4B-BCE9-FBC196E900B4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3A949A45-0F82-2A41-A04A-D7158202BF8E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006CE0F7-9AAD-7A4D-A38C-5482A3AAA806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BAC52768-FF94-4748-9948-75EDE22A7CAF}"/>
              </a:ext>
            </a:extLst>
          </p:cNvPr>
          <p:cNvGrpSpPr/>
          <p:nvPr/>
        </p:nvGrpSpPr>
        <p:grpSpPr>
          <a:xfrm>
            <a:off x="1227124" y="1373517"/>
            <a:ext cx="879475" cy="86200"/>
            <a:chOff x="894948" y="628023"/>
            <a:chExt cx="556890" cy="121752"/>
          </a:xfrm>
        </p:grpSpPr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6F827826-88DB-1C41-83A7-524C22062257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2074F3E6-B3D0-D64E-B5A8-28A4728DCF0B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D29671FE-9B4B-A04E-B5CE-26FC0F8A5189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FC775B24-286A-B14A-8CF3-59EAF8EA4308}"/>
              </a:ext>
            </a:extLst>
          </p:cNvPr>
          <p:cNvGrpSpPr/>
          <p:nvPr/>
        </p:nvGrpSpPr>
        <p:grpSpPr>
          <a:xfrm>
            <a:off x="1227124" y="1258997"/>
            <a:ext cx="1323975" cy="86200"/>
            <a:chOff x="894948" y="628023"/>
            <a:chExt cx="556890" cy="121752"/>
          </a:xfrm>
        </p:grpSpPr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7E4D8EEB-095D-B844-A962-B09FE283D582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89B9B39E-C2C8-1242-8980-61378423396A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7D269139-3304-C742-AE2C-E697F5B8E76F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C2B8D07F-C49A-C24D-8E00-11A93CB95D8D}"/>
              </a:ext>
            </a:extLst>
          </p:cNvPr>
          <p:cNvGrpSpPr/>
          <p:nvPr/>
        </p:nvGrpSpPr>
        <p:grpSpPr>
          <a:xfrm>
            <a:off x="1227124" y="1144477"/>
            <a:ext cx="1765293" cy="86200"/>
            <a:chOff x="894948" y="628023"/>
            <a:chExt cx="556890" cy="121752"/>
          </a:xfrm>
        </p:grpSpPr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DB47BB75-F5E2-3F48-BF06-49BF32811F49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CBC3A167-41D1-6545-A8D9-761D08B076BA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4CAD137C-E106-C945-B6E6-63D80AC8C458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64F5EBEA-7540-5749-BEE7-23C082986FA9}"/>
              </a:ext>
            </a:extLst>
          </p:cNvPr>
          <p:cNvGrpSpPr/>
          <p:nvPr/>
        </p:nvGrpSpPr>
        <p:grpSpPr>
          <a:xfrm>
            <a:off x="1227124" y="1029957"/>
            <a:ext cx="2200260" cy="86200"/>
            <a:chOff x="894948" y="628023"/>
            <a:chExt cx="556890" cy="121752"/>
          </a:xfrm>
        </p:grpSpPr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8F75F3D5-4DFE-FB4A-9703-8B3065D5D44F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35BB87F3-2256-604B-845F-36328CCD6434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8E04EE8D-732F-6C46-A51D-1229BE6D73C2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AA7605FE-D817-8944-B718-7C551E4E514A}"/>
              </a:ext>
            </a:extLst>
          </p:cNvPr>
          <p:cNvSpPr txBox="1"/>
          <p:nvPr/>
        </p:nvSpPr>
        <p:spPr>
          <a:xfrm>
            <a:off x="881454" y="14733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21931BA-7F1B-6742-BA3E-4478379A6861}"/>
              </a:ext>
            </a:extLst>
          </p:cNvPr>
          <p:cNvSpPr txBox="1"/>
          <p:nvPr/>
        </p:nvSpPr>
        <p:spPr>
          <a:xfrm>
            <a:off x="1335103" y="135847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FEAEE7C-D8A5-0F46-BFCF-4A087BCE261C}"/>
              </a:ext>
            </a:extLst>
          </p:cNvPr>
          <p:cNvSpPr txBox="1"/>
          <p:nvPr/>
        </p:nvSpPr>
        <p:spPr>
          <a:xfrm>
            <a:off x="1571203" y="123819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535ED13-9316-954B-AA9B-28B6BFA768E2}"/>
              </a:ext>
            </a:extLst>
          </p:cNvPr>
          <p:cNvSpPr txBox="1"/>
          <p:nvPr/>
        </p:nvSpPr>
        <p:spPr>
          <a:xfrm>
            <a:off x="1807304" y="112432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9CBDF36-9A57-6A4C-864A-10CE43FA1014}"/>
              </a:ext>
            </a:extLst>
          </p:cNvPr>
          <p:cNvSpPr txBox="1"/>
          <p:nvPr/>
        </p:nvSpPr>
        <p:spPr>
          <a:xfrm>
            <a:off x="2043404" y="100724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E4AA84E-86DD-1443-A625-D71D9A63E9E8}"/>
              </a:ext>
            </a:extLst>
          </p:cNvPr>
          <p:cNvSpPr txBox="1"/>
          <p:nvPr/>
        </p:nvSpPr>
        <p:spPr>
          <a:xfrm>
            <a:off x="2279505" y="89373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EFFBECD0-E5AA-D349-ADD9-9C47560EFCD7}"/>
              </a:ext>
            </a:extLst>
          </p:cNvPr>
          <p:cNvGrpSpPr/>
          <p:nvPr/>
        </p:nvGrpSpPr>
        <p:grpSpPr>
          <a:xfrm>
            <a:off x="5174521" y="1602556"/>
            <a:ext cx="450851" cy="86200"/>
            <a:chOff x="894948" y="628023"/>
            <a:chExt cx="556890" cy="121752"/>
          </a:xfrm>
        </p:grpSpPr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9E6076C5-20A4-2544-BFA6-4492B7CF4F7A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45954CF9-D7AF-4C4D-80B0-75F33E1E3EF4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FCB572EA-F46E-A543-B64A-B899165645A2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FE8E0689-8238-5744-9D28-D8F64BB4875D}"/>
              </a:ext>
            </a:extLst>
          </p:cNvPr>
          <p:cNvSpPr txBox="1"/>
          <p:nvPr/>
        </p:nvSpPr>
        <p:spPr>
          <a:xfrm>
            <a:off x="5280127" y="14733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8E282694-3963-4442-9FFA-1AA0E6C8CF14}"/>
              </a:ext>
            </a:extLst>
          </p:cNvPr>
          <p:cNvGrpSpPr/>
          <p:nvPr/>
        </p:nvGrpSpPr>
        <p:grpSpPr>
          <a:xfrm>
            <a:off x="5174522" y="1490267"/>
            <a:ext cx="901702" cy="86200"/>
            <a:chOff x="894948" y="628023"/>
            <a:chExt cx="556890" cy="121752"/>
          </a:xfrm>
        </p:grpSpPr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D6D4EE5B-2AA1-BB43-9953-BF70749D8995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A3BA5D61-9B81-3449-AA8E-C993D9D01ABC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77B31764-9B47-5D44-A49B-2AAAC2289550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334F74F-05C1-614A-8099-714586B1DC7C}"/>
              </a:ext>
            </a:extLst>
          </p:cNvPr>
          <p:cNvSpPr txBox="1"/>
          <p:nvPr/>
        </p:nvSpPr>
        <p:spPr>
          <a:xfrm>
            <a:off x="5496237" y="135698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CB2C6DCB-A251-5A4F-BC5F-301805015050}"/>
              </a:ext>
            </a:extLst>
          </p:cNvPr>
          <p:cNvGrpSpPr/>
          <p:nvPr/>
        </p:nvGrpSpPr>
        <p:grpSpPr>
          <a:xfrm>
            <a:off x="5174521" y="1373892"/>
            <a:ext cx="1330325" cy="86200"/>
            <a:chOff x="894948" y="628023"/>
            <a:chExt cx="556890" cy="121752"/>
          </a:xfrm>
        </p:grpSpPr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4BC7C151-ADD9-1245-B454-71868565B3DE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B3658CE5-092F-4E4F-9BB1-8E43091D6EED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364AE39A-01D0-694D-9CC6-C87558CF1A72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3B6EF03-E71E-874F-8B87-1B3A6FA26DFA}"/>
              </a:ext>
            </a:extLst>
          </p:cNvPr>
          <p:cNvSpPr txBox="1"/>
          <p:nvPr/>
        </p:nvSpPr>
        <p:spPr>
          <a:xfrm>
            <a:off x="5712347" y="12428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4E22A695-74D6-A543-9AEA-823839A2FCE4}"/>
              </a:ext>
            </a:extLst>
          </p:cNvPr>
          <p:cNvGrpSpPr/>
          <p:nvPr/>
        </p:nvGrpSpPr>
        <p:grpSpPr>
          <a:xfrm>
            <a:off x="5174521" y="1259712"/>
            <a:ext cx="1774825" cy="86200"/>
            <a:chOff x="894948" y="628023"/>
            <a:chExt cx="556890" cy="121752"/>
          </a:xfrm>
        </p:grpSpPr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4ED4FD0D-2809-624F-976C-C32DD9E2FEA1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BA791346-5AA1-DB48-BAB6-AD603B3C1343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8CE282C0-7BBB-2444-B178-D8F58EB94AD8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E22352D0-ED63-0649-B5CD-23C77196E7B2}"/>
              </a:ext>
            </a:extLst>
          </p:cNvPr>
          <p:cNvSpPr txBox="1"/>
          <p:nvPr/>
        </p:nvSpPr>
        <p:spPr>
          <a:xfrm>
            <a:off x="5928457" y="112953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6CDD451A-1D52-A846-9257-8CFA5AB3DCD9}"/>
              </a:ext>
            </a:extLst>
          </p:cNvPr>
          <p:cNvGrpSpPr/>
          <p:nvPr/>
        </p:nvGrpSpPr>
        <p:grpSpPr>
          <a:xfrm>
            <a:off x="5174521" y="1146445"/>
            <a:ext cx="2216143" cy="86200"/>
            <a:chOff x="894948" y="628023"/>
            <a:chExt cx="556890" cy="121752"/>
          </a:xfrm>
        </p:grpSpPr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28D45849-43A0-4448-886A-E7F13D617499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3FC9248C-B96A-AB45-9780-2F1865C467BE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85798F00-2B21-C240-9529-6DE76FB575F4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FA56EE70-AEB8-CE41-B8EA-FCA5F9AC7B50}"/>
              </a:ext>
            </a:extLst>
          </p:cNvPr>
          <p:cNvSpPr txBox="1"/>
          <p:nvPr/>
        </p:nvSpPr>
        <p:spPr>
          <a:xfrm>
            <a:off x="6144567" y="101304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5CA1971F-E943-A249-A912-59F88555DFCD}"/>
              </a:ext>
            </a:extLst>
          </p:cNvPr>
          <p:cNvGrpSpPr/>
          <p:nvPr/>
        </p:nvGrpSpPr>
        <p:grpSpPr>
          <a:xfrm>
            <a:off x="5174521" y="1029957"/>
            <a:ext cx="2651110" cy="86200"/>
            <a:chOff x="894948" y="628023"/>
            <a:chExt cx="556890" cy="121752"/>
          </a:xfrm>
        </p:grpSpPr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6B18C1D7-BF5A-6948-95A4-10C23EB757CA}"/>
                </a:ext>
              </a:extLst>
            </p:cNvPr>
            <p:cNvCxnSpPr/>
            <p:nvPr/>
          </p:nvCxnSpPr>
          <p:spPr>
            <a:xfrm>
              <a:off x="894948" y="628023"/>
              <a:ext cx="5568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8882D453-C235-374B-AE09-AE60926AF96F}"/>
                </a:ext>
              </a:extLst>
            </p:cNvPr>
            <p:cNvCxnSpPr>
              <a:cxnSpLocks/>
            </p:cNvCxnSpPr>
            <p:nvPr/>
          </p:nvCxnSpPr>
          <p:spPr>
            <a:xfrm>
              <a:off x="89494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D2D0F07E-C4DC-2148-BE95-2E14F5DFDC05}"/>
                </a:ext>
              </a:extLst>
            </p:cNvPr>
            <p:cNvCxnSpPr>
              <a:cxnSpLocks/>
            </p:cNvCxnSpPr>
            <p:nvPr/>
          </p:nvCxnSpPr>
          <p:spPr>
            <a:xfrm>
              <a:off x="1451838" y="628023"/>
              <a:ext cx="0" cy="1217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4F63A68F-D136-A944-8972-1C2847F13D91}"/>
              </a:ext>
            </a:extLst>
          </p:cNvPr>
          <p:cNvSpPr txBox="1"/>
          <p:nvPr/>
        </p:nvSpPr>
        <p:spPr>
          <a:xfrm>
            <a:off x="6360678" y="89373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*</a:t>
            </a:r>
            <a:endParaRPr kumimoji="1" lang="ja-JP" altLang="en-US" sz="80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38B4B5E3-6BF9-9F46-8F67-7A23C390F7DE}"/>
              </a:ext>
            </a:extLst>
          </p:cNvPr>
          <p:cNvSpPr txBox="1"/>
          <p:nvPr/>
        </p:nvSpPr>
        <p:spPr>
          <a:xfrm>
            <a:off x="-7486" y="4201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/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D1544484-6D84-7943-AF26-913E3F27CA50}"/>
              </a:ext>
            </a:extLst>
          </p:cNvPr>
          <p:cNvSpPr txBox="1"/>
          <p:nvPr/>
        </p:nvSpPr>
        <p:spPr>
          <a:xfrm>
            <a:off x="4340911" y="42015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74885A43-A598-7746-B894-2BFA1D3C827D}"/>
              </a:ext>
            </a:extLst>
          </p:cNvPr>
          <p:cNvSpPr txBox="1"/>
          <p:nvPr/>
        </p:nvSpPr>
        <p:spPr>
          <a:xfrm>
            <a:off x="3218410" y="6119913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* p&lt; 0.01</a:t>
            </a:r>
            <a:endParaRPr kumimoji="1" lang="ja-JP" altLang="en-US" sz="100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91A74973-045F-7341-9158-E38C15FD62EE}"/>
              </a:ext>
            </a:extLst>
          </p:cNvPr>
          <p:cNvSpPr txBox="1"/>
          <p:nvPr/>
        </p:nvSpPr>
        <p:spPr>
          <a:xfrm>
            <a:off x="7657202" y="6119912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* p&lt; 0.05</a:t>
            </a:r>
            <a:endParaRPr kumimoji="1" lang="ja-JP" altLang="en-US" sz="1000"/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F11CD99A-0CFE-0A4E-8DD9-322D6A46180E}"/>
              </a:ext>
            </a:extLst>
          </p:cNvPr>
          <p:cNvSpPr txBox="1"/>
          <p:nvPr/>
        </p:nvSpPr>
        <p:spPr>
          <a:xfrm rot="16200000">
            <a:off x="-685602" y="3391466"/>
            <a:ext cx="1540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Expression levels </a:t>
            </a:r>
            <a:r>
              <a:rPr lang="en-US" altLang="ja-JP" sz="1000" dirty="0"/>
              <a:t>(z-score)</a:t>
            </a:r>
            <a:endParaRPr kumimoji="1" lang="ja-JP" altLang="en-US" sz="100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E713F694-A30D-0440-B5E9-72CC28311B0A}"/>
              </a:ext>
            </a:extLst>
          </p:cNvPr>
          <p:cNvSpPr txBox="1"/>
          <p:nvPr/>
        </p:nvSpPr>
        <p:spPr>
          <a:xfrm rot="16200000">
            <a:off x="3727087" y="3391467"/>
            <a:ext cx="1540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Expression levels </a:t>
            </a:r>
            <a:r>
              <a:rPr lang="en-US" altLang="ja-JP" sz="1000" dirty="0"/>
              <a:t>(z-score)</a:t>
            </a:r>
            <a:endParaRPr kumimoji="1" lang="ja-JP" altLang="en-US" sz="1000"/>
          </a:p>
        </p:txBody>
      </p:sp>
      <p:pic>
        <p:nvPicPr>
          <p:cNvPr id="104" name="図 103">
            <a:extLst>
              <a:ext uri="{FF2B5EF4-FFF2-40B4-BE49-F238E27FC236}">
                <a16:creationId xmlns:a16="http://schemas.microsoft.com/office/drawing/2014/main" id="{4C1AB3C0-AEC1-8444-A079-67647454BED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4511" t="36498" b="38433"/>
          <a:stretch/>
        </p:blipFill>
        <p:spPr>
          <a:xfrm>
            <a:off x="3628421" y="1645656"/>
            <a:ext cx="715241" cy="1157622"/>
          </a:xfrm>
          <a:prstGeom prst="rect">
            <a:avLst/>
          </a:prstGeom>
        </p:spPr>
      </p:pic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4B6C345F-737E-DD49-BFEE-FEDA18A97E19}"/>
              </a:ext>
            </a:extLst>
          </p:cNvPr>
          <p:cNvSpPr txBox="1"/>
          <p:nvPr/>
        </p:nvSpPr>
        <p:spPr>
          <a:xfrm>
            <a:off x="8018349" y="1415140"/>
            <a:ext cx="72648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Cell type</a:t>
            </a:r>
            <a:endParaRPr kumimoji="1" lang="ja-JP" altLang="en-US" sz="1200"/>
          </a:p>
        </p:txBody>
      </p:sp>
      <p:pic>
        <p:nvPicPr>
          <p:cNvPr id="106" name="図 105">
            <a:extLst>
              <a:ext uri="{FF2B5EF4-FFF2-40B4-BE49-F238E27FC236}">
                <a16:creationId xmlns:a16="http://schemas.microsoft.com/office/drawing/2014/main" id="{C13E2D65-925A-B24C-A738-B7CC2D558D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4511" t="36498" b="38433"/>
          <a:stretch/>
        </p:blipFill>
        <p:spPr>
          <a:xfrm>
            <a:off x="8063237" y="1688756"/>
            <a:ext cx="715241" cy="1157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9493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75</TotalTime>
  <Words>43</Words>
  <Application>Microsoft Macintosh PowerPoint</Application>
  <PresentationFormat>ユーザー設定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maekawa@gmail.com</dc:creator>
  <cp:lastModifiedBy>RYO MAEKAWA</cp:lastModifiedBy>
  <cp:revision>21</cp:revision>
  <dcterms:created xsi:type="dcterms:W3CDTF">2018-09-10T10:23:53Z</dcterms:created>
  <dcterms:modified xsi:type="dcterms:W3CDTF">2019-03-19T10:56:56Z</dcterms:modified>
</cp:coreProperties>
</file>